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1197" r:id="rId2"/>
    <p:sldId id="1204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16" autoAdjust="0"/>
    <p:restoredTop sz="75439" autoAdjust="0"/>
  </p:normalViewPr>
  <p:slideViewPr>
    <p:cSldViewPr snapToGrid="0">
      <p:cViewPr varScale="1">
        <p:scale>
          <a:sx n="93" d="100"/>
          <a:sy n="93" d="100"/>
        </p:scale>
        <p:origin x="11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279F77-7E64-42AD-AB77-7FBEB718D02A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3D2A9D-D394-4060-9A34-0841AC7246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4531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2F9CF-A1F9-4E8E-B17F-EF7BBC31A7B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8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60BC6B-A224-4B6A-A335-EE5F44C60F6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145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7074E8-E1B1-47C3-B7DE-48935CA4085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2260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1C948-F5EE-0640-44FB-A43BBD24FF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A62212-8D8A-2C31-50FC-122EDAAAC8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EC482B-5A39-4274-43ED-D348C8E84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1F5B2-DC4A-0615-5E44-AE9D6517B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4D278-AC69-D45C-D878-BA287F97E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007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764CF-980D-4174-2233-5B5EB2D7B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97B0D5-7508-CD19-3FDC-98FF07C952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0DAD1-2020-BA2A-F2C7-4CFAE7874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C51D9-249C-79D6-C65E-360E80CC0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B833B-C791-FE88-895C-885B84B8F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836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64E803-6493-19C0-FD50-2B9E1F4B03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E51231-69A2-B136-9E15-5413A0CB43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B413B9-410B-7D77-0EBD-BF5DAE0D2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C6F24B-4067-AB01-E553-94A155DE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62E20-FCFD-E4D0-6C9E-C62A80D01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032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138A2-AF3D-71DB-3BAC-47A2157EEE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79E538-727A-55E7-C02D-2B1BB52961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F286B-81DB-188A-6B0D-AF6F5DFCC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49F5FB-8397-C719-E767-CC8AE00FE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9A2549-736E-9B6E-FC51-D75FD0AF2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793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221C6-BE4E-5E67-BD33-D1B79DA264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77ED6-0C2F-272B-6E2A-47A433E2D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8F5B88-A84E-E091-D515-37659D486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8AE0B5-653C-F403-2283-7C5C9119A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07EC7A-D6A7-0FC7-4927-FA0C7ED4F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214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670E1-2E59-53E2-A1EB-0E17D84C0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A69610-9495-85F4-910B-9117F4D6DE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38F06B-0406-1537-8C29-A7DC431881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207C2A-3864-230D-1758-00AF6FE5F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FE3805-9E2B-E53C-9793-E2915334A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8F737D-01F6-91D4-3843-FAED1E1F5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527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44D3F-0116-296D-A31F-62D416857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F9633C-FA87-A26E-B2EC-296197FBBA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21403F-3018-8E37-4F94-C91A8936E3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92B292-806F-61CD-0AAD-A509C9CD28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22324A-3FE4-210C-B2F2-B4C64D1E85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27ED89-A8C1-C8D3-9D4C-4F1B964C0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3ACAD6-B265-F5E9-F561-CF18D268D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43D0A3-4042-B7E5-0F5D-9B4CDE409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348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054AF-51C3-1564-7280-D410C826F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E08613-9424-C923-97F9-2AED6CCA4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110AED-6885-8FBB-27AB-66408E948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808840-D2A7-D753-D3C8-560EF83D0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746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62B4DD-8461-BCF6-CEA5-9C92690BA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8234E1-1B38-1A62-CDFD-19089DBA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B28586-3F5F-3B1E-9134-AE41591AF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191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0967E-22FC-E11D-92AB-7944C4321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6A8ABF-F010-BC88-286E-3F45C18F87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28F7D8-BD46-CFB0-8C20-8723E6A819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01F696-8758-47A0-CD6C-6F30A48BF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82A9F3-DADB-B555-5D87-C4885EA2D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218833-4EC6-B7C3-D179-05251327B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0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E66B6-E39E-0D83-A990-D67F25BB3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D26E11-4C48-DCBF-9FE9-6DA7B868F5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3E0268-BF9A-CC87-A54E-ABFAFA5FC7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736D18-390A-FBE2-538C-B4B167420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C3E311-B433-846E-CAEB-548B37CAE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59776D-C835-2FB2-F62D-88A7D4C37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67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32D1FD5-7907-B23B-A63D-4987D27341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2FDC62-6495-B7CC-FA71-2C0A4E14A3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3CEA9-4D4B-FA18-8C2D-CA5D117699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B3E4B7-2D19-4F72-A0A4-78540E6FC987}" type="datetimeFigureOut">
              <a:rPr lang="en-US" smtClean="0"/>
              <a:t>5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6A4E7A-407B-9B99-981D-0801B89087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AAB6FB-4449-A642-5BEA-F0E351C6E7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6838EE-3356-46D3-92E0-4AD3333C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13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2ADA0F1-8B14-3C93-8728-164F1ED8DDF1}"/>
              </a:ext>
            </a:extLst>
          </p:cNvPr>
          <p:cNvSpPr/>
          <p:nvPr/>
        </p:nvSpPr>
        <p:spPr>
          <a:xfrm>
            <a:off x="3456363" y="136068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E8A5B5-718F-7918-F151-CE6B791E1B5D}"/>
              </a:ext>
            </a:extLst>
          </p:cNvPr>
          <p:cNvSpPr/>
          <p:nvPr/>
        </p:nvSpPr>
        <p:spPr>
          <a:xfrm>
            <a:off x="3685214" y="136068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66B1974-1B42-4D6B-5C3D-B9EFD7A5D466}"/>
              </a:ext>
            </a:extLst>
          </p:cNvPr>
          <p:cNvSpPr/>
          <p:nvPr/>
        </p:nvSpPr>
        <p:spPr>
          <a:xfrm>
            <a:off x="3912559" y="136068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3F49081-1E13-A1E8-C8D5-2B3BC6A0DBFE}"/>
              </a:ext>
            </a:extLst>
          </p:cNvPr>
          <p:cNvSpPr/>
          <p:nvPr/>
        </p:nvSpPr>
        <p:spPr>
          <a:xfrm>
            <a:off x="4153454" y="136068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1F193E5-08D9-74B0-9A13-DEF6C8B2F88D}"/>
              </a:ext>
            </a:extLst>
          </p:cNvPr>
          <p:cNvSpPr/>
          <p:nvPr/>
        </p:nvSpPr>
        <p:spPr>
          <a:xfrm>
            <a:off x="4609651" y="1360687"/>
            <a:ext cx="169343" cy="1288703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6462302-560F-C1CC-EB9E-64A74788FDD8}"/>
              </a:ext>
            </a:extLst>
          </p:cNvPr>
          <p:cNvSpPr/>
          <p:nvPr/>
        </p:nvSpPr>
        <p:spPr>
          <a:xfrm>
            <a:off x="2832083" y="3391443"/>
            <a:ext cx="104212" cy="112218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C5D9124-CB67-E439-CD02-C0B47D56B8F9}"/>
              </a:ext>
            </a:extLst>
          </p:cNvPr>
          <p:cNvSpPr/>
          <p:nvPr/>
        </p:nvSpPr>
        <p:spPr>
          <a:xfrm>
            <a:off x="2976620" y="3391443"/>
            <a:ext cx="104212" cy="112218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C70D21E-5E5C-C128-CC68-E69A1C5F3C17}"/>
              </a:ext>
            </a:extLst>
          </p:cNvPr>
          <p:cNvSpPr/>
          <p:nvPr/>
        </p:nvSpPr>
        <p:spPr>
          <a:xfrm>
            <a:off x="3133202" y="3391443"/>
            <a:ext cx="104212" cy="112218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7BC18B1-BD13-407F-8848-4179D08138D8}"/>
              </a:ext>
            </a:extLst>
          </p:cNvPr>
          <p:cNvSpPr/>
          <p:nvPr/>
        </p:nvSpPr>
        <p:spPr>
          <a:xfrm>
            <a:off x="3289783" y="3391443"/>
            <a:ext cx="104212" cy="112218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7088B39-7A57-D74F-159E-6CAB697964DC}"/>
              </a:ext>
            </a:extLst>
          </p:cNvPr>
          <p:cNvSpPr/>
          <p:nvPr/>
        </p:nvSpPr>
        <p:spPr>
          <a:xfrm>
            <a:off x="3583374" y="3391443"/>
            <a:ext cx="104212" cy="112218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D9ADA44-113A-14E1-C555-4E63B534CA43}"/>
              </a:ext>
            </a:extLst>
          </p:cNvPr>
          <p:cNvCxnSpPr>
            <a:cxnSpLocks/>
            <a:stCxn id="41" idx="2"/>
            <a:endCxn id="9" idx="0"/>
          </p:cNvCxnSpPr>
          <p:nvPr/>
        </p:nvCxnSpPr>
        <p:spPr>
          <a:xfrm flipH="1">
            <a:off x="2884189" y="2794216"/>
            <a:ext cx="307211" cy="597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0438BA3-9301-E868-1DF1-05239DDA38BF}"/>
              </a:ext>
            </a:extLst>
          </p:cNvPr>
          <p:cNvCxnSpPr>
            <a:cxnSpLocks/>
            <a:stCxn id="41" idx="2"/>
            <a:endCxn id="10" idx="0"/>
          </p:cNvCxnSpPr>
          <p:nvPr/>
        </p:nvCxnSpPr>
        <p:spPr>
          <a:xfrm flipH="1">
            <a:off x="3028726" y="2794216"/>
            <a:ext cx="162674" cy="597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FF5838D-EF90-D59F-4C11-76EF2B73F1E4}"/>
              </a:ext>
            </a:extLst>
          </p:cNvPr>
          <p:cNvCxnSpPr>
            <a:cxnSpLocks/>
            <a:stCxn id="41" idx="2"/>
            <a:endCxn id="11" idx="0"/>
          </p:cNvCxnSpPr>
          <p:nvPr/>
        </p:nvCxnSpPr>
        <p:spPr>
          <a:xfrm flipH="1">
            <a:off x="3185308" y="2794216"/>
            <a:ext cx="6092" cy="597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836A894-E46A-D398-8DBB-D842A8458893}"/>
              </a:ext>
            </a:extLst>
          </p:cNvPr>
          <p:cNvCxnSpPr>
            <a:cxnSpLocks/>
            <a:stCxn id="41" idx="2"/>
            <a:endCxn id="12" idx="0"/>
          </p:cNvCxnSpPr>
          <p:nvPr/>
        </p:nvCxnSpPr>
        <p:spPr>
          <a:xfrm>
            <a:off x="3191400" y="2794216"/>
            <a:ext cx="150489" cy="597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FEEA123-BDE2-92D8-6528-84AAED6556F5}"/>
              </a:ext>
            </a:extLst>
          </p:cNvPr>
          <p:cNvCxnSpPr>
            <a:cxnSpLocks/>
            <a:stCxn id="41" idx="2"/>
            <a:endCxn id="13" idx="0"/>
          </p:cNvCxnSpPr>
          <p:nvPr/>
        </p:nvCxnSpPr>
        <p:spPr>
          <a:xfrm>
            <a:off x="3191400" y="2794216"/>
            <a:ext cx="444080" cy="5972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AB9281D4-EFA3-A63A-BFC8-099ED2B4A7E4}"/>
              </a:ext>
            </a:extLst>
          </p:cNvPr>
          <p:cNvSpPr/>
          <p:nvPr/>
        </p:nvSpPr>
        <p:spPr>
          <a:xfrm rot="5400000">
            <a:off x="7127114" y="3571818"/>
            <a:ext cx="189664" cy="1794951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51F74928-3399-76EC-5EDA-FC52E8F6BABA}"/>
              </a:ext>
            </a:extLst>
          </p:cNvPr>
          <p:cNvSpPr/>
          <p:nvPr/>
        </p:nvSpPr>
        <p:spPr>
          <a:xfrm>
            <a:off x="5517428" y="1971972"/>
            <a:ext cx="1602443" cy="1007999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3971">
              <a:spcAft>
                <a:spcPts val="528"/>
              </a:spcAft>
            </a:pPr>
            <a:r>
              <a:rPr lang="en-US" sz="1400" b="1" kern="1200" dirty="0">
                <a:solidFill>
                  <a:srgbClr val="55555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E881FBFA-17D7-4072-94AE-C75CBD9E0D2E}"/>
              </a:ext>
            </a:extLst>
          </p:cNvPr>
          <p:cNvSpPr/>
          <p:nvPr/>
        </p:nvSpPr>
        <p:spPr>
          <a:xfrm>
            <a:off x="7576068" y="1955896"/>
            <a:ext cx="1602443" cy="1007999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683971">
              <a:spcAft>
                <a:spcPts val="528"/>
              </a:spcAft>
            </a:pPr>
            <a:r>
              <a:rPr lang="en-US" sz="1400" b="1" kern="1200">
                <a:solidFill>
                  <a:srgbClr val="55555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A2587DB-3993-3CF7-2F9F-04947E91D61E}"/>
              </a:ext>
            </a:extLst>
          </p:cNvPr>
          <p:cNvSpPr/>
          <p:nvPr/>
        </p:nvSpPr>
        <p:spPr>
          <a:xfrm>
            <a:off x="5373091" y="3501781"/>
            <a:ext cx="338220" cy="9676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2F57DE8-A269-8C91-D543-FF54E62C5621}"/>
              </a:ext>
            </a:extLst>
          </p:cNvPr>
          <p:cNvSpPr/>
          <p:nvPr/>
        </p:nvSpPr>
        <p:spPr>
          <a:xfrm>
            <a:off x="5895252" y="3503637"/>
            <a:ext cx="338220" cy="9676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971E937-BDD8-6C39-7418-8551E814F20B}"/>
              </a:ext>
            </a:extLst>
          </p:cNvPr>
          <p:cNvSpPr/>
          <p:nvPr/>
        </p:nvSpPr>
        <p:spPr>
          <a:xfrm>
            <a:off x="6355903" y="3509905"/>
            <a:ext cx="338220" cy="9676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38B266D-B8F3-BCD3-4AFF-10CFBC46A400}"/>
              </a:ext>
            </a:extLst>
          </p:cNvPr>
          <p:cNvSpPr/>
          <p:nvPr/>
        </p:nvSpPr>
        <p:spPr>
          <a:xfrm>
            <a:off x="6838621" y="3507270"/>
            <a:ext cx="338220" cy="9676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D9ED4A4-EF37-8DD8-81AD-82062C7379C0}"/>
              </a:ext>
            </a:extLst>
          </p:cNvPr>
          <p:cNvSpPr/>
          <p:nvPr/>
        </p:nvSpPr>
        <p:spPr>
          <a:xfrm>
            <a:off x="7409148" y="3521562"/>
            <a:ext cx="338220" cy="96767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4596899-5A74-BEB5-4CB2-D2FB0DFB1D55}"/>
              </a:ext>
            </a:extLst>
          </p:cNvPr>
          <p:cNvSpPr/>
          <p:nvPr/>
        </p:nvSpPr>
        <p:spPr>
          <a:xfrm>
            <a:off x="7869189" y="3511828"/>
            <a:ext cx="338220" cy="96767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C90816D-C574-0290-B364-8155269631B9}"/>
              </a:ext>
            </a:extLst>
          </p:cNvPr>
          <p:cNvSpPr/>
          <p:nvPr/>
        </p:nvSpPr>
        <p:spPr>
          <a:xfrm>
            <a:off x="8365436" y="3512054"/>
            <a:ext cx="338220" cy="96767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40F66B1-A838-0CBC-CC57-8D4AD7509EB1}"/>
              </a:ext>
            </a:extLst>
          </p:cNvPr>
          <p:cNvSpPr/>
          <p:nvPr/>
        </p:nvSpPr>
        <p:spPr>
          <a:xfrm>
            <a:off x="8855357" y="3508818"/>
            <a:ext cx="338220" cy="96767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6A3714D1-6C26-750E-8FE6-79E0558FA985}"/>
              </a:ext>
            </a:extLst>
          </p:cNvPr>
          <p:cNvCxnSpPr>
            <a:cxnSpLocks/>
            <a:stCxn id="22" idx="2"/>
          </p:cNvCxnSpPr>
          <p:nvPr/>
        </p:nvCxnSpPr>
        <p:spPr>
          <a:xfrm>
            <a:off x="5542201" y="3598548"/>
            <a:ext cx="900969" cy="6991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FA3A6FF-5809-853F-EF25-AC8CDBB8A888}"/>
              </a:ext>
            </a:extLst>
          </p:cNvPr>
          <p:cNvCxnSpPr>
            <a:cxnSpLocks/>
            <a:stCxn id="23" idx="2"/>
          </p:cNvCxnSpPr>
          <p:nvPr/>
        </p:nvCxnSpPr>
        <p:spPr>
          <a:xfrm>
            <a:off x="6064362" y="3600404"/>
            <a:ext cx="607695" cy="6991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6FC2408D-78DC-A842-2D42-EE78EB3CD718}"/>
              </a:ext>
            </a:extLst>
          </p:cNvPr>
          <p:cNvCxnSpPr>
            <a:cxnSpLocks/>
            <a:stCxn id="24" idx="2"/>
          </p:cNvCxnSpPr>
          <p:nvPr/>
        </p:nvCxnSpPr>
        <p:spPr>
          <a:xfrm>
            <a:off x="6525013" y="3606672"/>
            <a:ext cx="294379" cy="6991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64AD276F-0861-A4A6-DEA9-EE433E6C8447}"/>
              </a:ext>
            </a:extLst>
          </p:cNvPr>
          <p:cNvCxnSpPr>
            <a:cxnSpLocks/>
            <a:stCxn id="25" idx="2"/>
          </p:cNvCxnSpPr>
          <p:nvPr/>
        </p:nvCxnSpPr>
        <p:spPr>
          <a:xfrm>
            <a:off x="7007730" y="3604037"/>
            <a:ext cx="26452" cy="6991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AF8BD56-1FAC-ED53-74F0-B215C7ACDB09}"/>
              </a:ext>
            </a:extLst>
          </p:cNvPr>
          <p:cNvCxnSpPr>
            <a:cxnSpLocks/>
            <a:stCxn id="26" idx="2"/>
          </p:cNvCxnSpPr>
          <p:nvPr/>
        </p:nvCxnSpPr>
        <p:spPr>
          <a:xfrm flipH="1">
            <a:off x="7418743" y="3618329"/>
            <a:ext cx="159515" cy="69917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79A78344-56EE-B854-11B9-F3BAEAFF5D6E}"/>
              </a:ext>
            </a:extLst>
          </p:cNvPr>
          <p:cNvCxnSpPr>
            <a:cxnSpLocks/>
            <a:stCxn id="27" idx="2"/>
          </p:cNvCxnSpPr>
          <p:nvPr/>
        </p:nvCxnSpPr>
        <p:spPr>
          <a:xfrm flipH="1">
            <a:off x="7618688" y="3608595"/>
            <a:ext cx="419611" cy="69616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F7F43276-4B75-B96D-4D24-B4418E3DB57E}"/>
              </a:ext>
            </a:extLst>
          </p:cNvPr>
          <p:cNvCxnSpPr>
            <a:cxnSpLocks/>
            <a:stCxn id="28" idx="2"/>
          </p:cNvCxnSpPr>
          <p:nvPr/>
        </p:nvCxnSpPr>
        <p:spPr>
          <a:xfrm flipH="1">
            <a:off x="7887519" y="3608822"/>
            <a:ext cx="647027" cy="69282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CA56BA2B-E259-261B-F3C8-DAAA3BE1684A}"/>
              </a:ext>
            </a:extLst>
          </p:cNvPr>
          <p:cNvCxnSpPr>
            <a:cxnSpLocks/>
            <a:stCxn id="29" idx="2"/>
          </p:cNvCxnSpPr>
          <p:nvPr/>
        </p:nvCxnSpPr>
        <p:spPr>
          <a:xfrm flipH="1">
            <a:off x="8038299" y="3605585"/>
            <a:ext cx="986168" cy="69917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or: Curved 37">
            <a:extLst>
              <a:ext uri="{FF2B5EF4-FFF2-40B4-BE49-F238E27FC236}">
                <a16:creationId xmlns:a16="http://schemas.microsoft.com/office/drawing/2014/main" id="{6473C79D-89DD-A4F3-5D86-A1EFFD7CE50C}"/>
              </a:ext>
            </a:extLst>
          </p:cNvPr>
          <p:cNvCxnSpPr>
            <a:cxnSpLocks/>
          </p:cNvCxnSpPr>
          <p:nvPr/>
        </p:nvCxnSpPr>
        <p:spPr>
          <a:xfrm rot="16200000" flipH="1">
            <a:off x="4897648" y="2170704"/>
            <a:ext cx="1725072" cy="2983820"/>
          </a:xfrm>
          <a:prstGeom prst="curvedConnector3">
            <a:avLst>
              <a:gd name="adj1" fmla="val 121444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27EC7BED-8DD6-106A-0B57-717DFE3559DD}"/>
              </a:ext>
            </a:extLst>
          </p:cNvPr>
          <p:cNvSpPr txBox="1"/>
          <p:nvPr/>
        </p:nvSpPr>
        <p:spPr>
          <a:xfrm>
            <a:off x="6646112" y="3167759"/>
            <a:ext cx="679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33DDB2A-79D7-B980-55AF-2D18B47C5612}"/>
              </a:ext>
            </a:extLst>
          </p:cNvPr>
          <p:cNvSpPr txBox="1"/>
          <p:nvPr/>
        </p:nvSpPr>
        <p:spPr>
          <a:xfrm>
            <a:off x="8689172" y="3170444"/>
            <a:ext cx="773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81D2E0F-54F7-2B59-EE28-59D9A4CC95BC}"/>
              </a:ext>
            </a:extLst>
          </p:cNvPr>
          <p:cNvSpPr/>
          <p:nvPr/>
        </p:nvSpPr>
        <p:spPr>
          <a:xfrm>
            <a:off x="1903239" y="1216870"/>
            <a:ext cx="2576321" cy="1577346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FA435D9-8F4A-C94A-8E15-1E095C9AD774}"/>
              </a:ext>
            </a:extLst>
          </p:cNvPr>
          <p:cNvSpPr txBox="1"/>
          <p:nvPr/>
        </p:nvSpPr>
        <p:spPr>
          <a:xfrm>
            <a:off x="1799087" y="4838925"/>
            <a:ext cx="3672785" cy="815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232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id search for </a:t>
            </a:r>
            <a:r>
              <a:rPr lang="en-US" sz="12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paramete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uning</a:t>
            </a:r>
            <a:endParaRPr lang="en-US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et the </a:t>
            </a:r>
            <a:r>
              <a:rPr lang="en-US" sz="12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st mode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8ABB148-B912-0ECD-9D32-5608D4B00441}"/>
              </a:ext>
            </a:extLst>
          </p:cNvPr>
          <p:cNvSpPr txBox="1"/>
          <p:nvPr/>
        </p:nvSpPr>
        <p:spPr>
          <a:xfrm>
            <a:off x="4680092" y="945782"/>
            <a:ext cx="21636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idate the resul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95A5A56C-9D70-8108-310A-770B24065A82}"/>
              </a:ext>
            </a:extLst>
          </p:cNvPr>
          <p:cNvCxnSpPr>
            <a:cxnSpLocks/>
            <a:stCxn id="43" idx="2"/>
            <a:endCxn id="8" idx="3"/>
          </p:cNvCxnSpPr>
          <p:nvPr/>
        </p:nvCxnSpPr>
        <p:spPr>
          <a:xfrm flipH="1">
            <a:off x="4778994" y="1253559"/>
            <a:ext cx="982910" cy="75148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6F5EDB3B-FC67-F289-A69C-3A8E53AA9BEF}"/>
              </a:ext>
            </a:extLst>
          </p:cNvPr>
          <p:cNvSpPr txBox="1"/>
          <p:nvPr/>
        </p:nvSpPr>
        <p:spPr>
          <a:xfrm>
            <a:off x="5188604" y="3162321"/>
            <a:ext cx="689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H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53DCB4E-E93C-4766-62EF-835D2923FD7D}"/>
              </a:ext>
            </a:extLst>
          </p:cNvPr>
          <p:cNvSpPr txBox="1"/>
          <p:nvPr/>
        </p:nvSpPr>
        <p:spPr>
          <a:xfrm>
            <a:off x="5668526" y="3170445"/>
            <a:ext cx="755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HW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BC70DEB-6BD2-96D7-C2F7-35D4B8F33DD2}"/>
              </a:ext>
            </a:extLst>
          </p:cNvPr>
          <p:cNvSpPr txBox="1"/>
          <p:nvPr/>
        </p:nvSpPr>
        <p:spPr>
          <a:xfrm>
            <a:off x="6248036" y="3176713"/>
            <a:ext cx="5458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F666F38-4E07-9C49-827C-3192F28505B0}"/>
              </a:ext>
            </a:extLst>
          </p:cNvPr>
          <p:cNvSpPr txBox="1"/>
          <p:nvPr/>
        </p:nvSpPr>
        <p:spPr>
          <a:xfrm>
            <a:off x="7252198" y="3162321"/>
            <a:ext cx="652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H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4BFBB37-B012-0FF0-4812-8A8DC5F3BB76}"/>
              </a:ext>
            </a:extLst>
          </p:cNvPr>
          <p:cNvSpPr txBox="1"/>
          <p:nvPr/>
        </p:nvSpPr>
        <p:spPr>
          <a:xfrm>
            <a:off x="7752851" y="3162321"/>
            <a:ext cx="674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HW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A6ED405-601C-424B-A41D-F06BE474B26D}"/>
              </a:ext>
            </a:extLst>
          </p:cNvPr>
          <p:cNvSpPr txBox="1"/>
          <p:nvPr/>
        </p:nvSpPr>
        <p:spPr>
          <a:xfrm>
            <a:off x="8293763" y="3170443"/>
            <a:ext cx="482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4672">
              <a:spcAft>
                <a:spcPts val="600"/>
              </a:spcAft>
            </a:pPr>
            <a:r>
              <a:rPr lang="en-US" sz="1400" b="1" kern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1B6A6E1-E58B-1171-4166-CEBF985C3AB8}"/>
              </a:ext>
            </a:extLst>
          </p:cNvPr>
          <p:cNvSpPr/>
          <p:nvPr/>
        </p:nvSpPr>
        <p:spPr>
          <a:xfrm>
            <a:off x="2689376" y="3214559"/>
            <a:ext cx="1135433" cy="1391964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465BE70D-9B6E-AA28-6921-374EC923CAE6}"/>
              </a:ext>
            </a:extLst>
          </p:cNvPr>
          <p:cNvSpPr/>
          <p:nvPr/>
        </p:nvSpPr>
        <p:spPr>
          <a:xfrm>
            <a:off x="3214928" y="1357030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CB04582B-CE05-7694-38A4-61A25D04B86E}"/>
              </a:ext>
            </a:extLst>
          </p:cNvPr>
          <p:cNvSpPr/>
          <p:nvPr/>
        </p:nvSpPr>
        <p:spPr>
          <a:xfrm>
            <a:off x="2960913" y="1357028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3533784C-CDD5-70C7-F669-8A4B5DEAF784}"/>
              </a:ext>
            </a:extLst>
          </p:cNvPr>
          <p:cNvSpPr/>
          <p:nvPr/>
        </p:nvSpPr>
        <p:spPr>
          <a:xfrm>
            <a:off x="2692998" y="135702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2693E36C-36A3-5E1D-CC59-7F4F75CD009D}"/>
              </a:ext>
            </a:extLst>
          </p:cNvPr>
          <p:cNvSpPr/>
          <p:nvPr/>
        </p:nvSpPr>
        <p:spPr>
          <a:xfrm>
            <a:off x="2406479" y="135702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415181D6-E9C9-F88D-F809-3638005A552D}"/>
              </a:ext>
            </a:extLst>
          </p:cNvPr>
          <p:cNvSpPr/>
          <p:nvPr/>
        </p:nvSpPr>
        <p:spPr>
          <a:xfrm>
            <a:off x="2124873" y="1357027"/>
            <a:ext cx="169343" cy="1288703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FF28714C-0ADD-57FF-2A52-E1D65C06047F}"/>
              </a:ext>
            </a:extLst>
          </p:cNvPr>
          <p:cNvCxnSpPr>
            <a:cxnSpLocks/>
            <a:endCxn id="51" idx="2"/>
          </p:cNvCxnSpPr>
          <p:nvPr/>
        </p:nvCxnSpPr>
        <p:spPr>
          <a:xfrm flipV="1">
            <a:off x="3257092" y="4606523"/>
            <a:ext cx="1" cy="44696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2D0BE00C-2175-9092-28C9-85DDBBE3717B}"/>
              </a:ext>
            </a:extLst>
          </p:cNvPr>
          <p:cNvSpPr txBox="1"/>
          <p:nvPr/>
        </p:nvSpPr>
        <p:spPr>
          <a:xfrm>
            <a:off x="338236" y="1800472"/>
            <a:ext cx="16256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uter Loop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 = 1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5C807A9-9CF7-72A9-1E1B-7219CDE32920}"/>
              </a:ext>
            </a:extLst>
          </p:cNvPr>
          <p:cNvSpPr txBox="1"/>
          <p:nvPr/>
        </p:nvSpPr>
        <p:spPr>
          <a:xfrm>
            <a:off x="361632" y="3727214"/>
            <a:ext cx="16256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nner Loop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 = 5</a:t>
            </a:r>
          </a:p>
        </p:txBody>
      </p:sp>
      <p:pic>
        <p:nvPicPr>
          <p:cNvPr id="2" name="Content Placeholder 4">
            <a:extLst>
              <a:ext uri="{FF2B5EF4-FFF2-40B4-BE49-F238E27FC236}">
                <a16:creationId xmlns:a16="http://schemas.microsoft.com/office/drawing/2014/main" id="{1791EA15-C926-9629-B164-0EE297E692D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9642765" y="4103433"/>
            <a:ext cx="1853989" cy="2666992"/>
          </a:xfrm>
        </p:spPr>
      </p:pic>
      <p:cxnSp>
        <p:nvCxnSpPr>
          <p:cNvPr id="59" name="Connector: Curved 58">
            <a:extLst>
              <a:ext uri="{FF2B5EF4-FFF2-40B4-BE49-F238E27FC236}">
                <a16:creationId xmlns:a16="http://schemas.microsoft.com/office/drawing/2014/main" id="{13D270CB-0B4E-819B-B30B-2CB314697FB0}"/>
              </a:ext>
            </a:extLst>
          </p:cNvPr>
          <p:cNvCxnSpPr>
            <a:cxnSpLocks/>
            <a:endCxn id="19" idx="3"/>
          </p:cNvCxnSpPr>
          <p:nvPr/>
        </p:nvCxnSpPr>
        <p:spPr>
          <a:xfrm rot="10800000">
            <a:off x="7221947" y="4564127"/>
            <a:ext cx="2770345" cy="789133"/>
          </a:xfrm>
          <a:prstGeom prst="curvedConnector4">
            <a:avLst>
              <a:gd name="adj1" fmla="val 48288"/>
              <a:gd name="adj2" fmla="val -30681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52987409-2816-8347-87F0-12CFBD030048}"/>
              </a:ext>
            </a:extLst>
          </p:cNvPr>
          <p:cNvSpPr txBox="1"/>
          <p:nvPr/>
        </p:nvSpPr>
        <p:spPr>
          <a:xfrm>
            <a:off x="6113152" y="5621491"/>
            <a:ext cx="4188514" cy="728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232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51460" indent="-251460" defTabSz="804672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ratify the data (NHW) based on where the patient live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8C902AD-D526-E801-69F6-ED4CBCFCA633}"/>
              </a:ext>
            </a:extLst>
          </p:cNvPr>
          <p:cNvSpPr txBox="1"/>
          <p:nvPr/>
        </p:nvSpPr>
        <p:spPr>
          <a:xfrm>
            <a:off x="152035" y="157218"/>
            <a:ext cx="110596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89432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fill="hold">
                      <p:stCondLst>
                        <p:cond delay="indefinite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" fill="hold">
                      <p:stCondLst>
                        <p:cond delay="indefinite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4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7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0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3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6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9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2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3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5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6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8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9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61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2" fill="hold">
                      <p:stCondLst>
                        <p:cond delay="indefinite"/>
                      </p:stCondLst>
                      <p:childTnLst>
                        <p:par>
                          <p:cTn id="63" fill="hold">
                            <p:stCondLst>
                              <p:cond delay="0"/>
                            </p:stCondLst>
                            <p:childTnLst>
                              <p:par>
                                <p:cTn id="64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6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" fill="hold">
                      <p:stCondLst>
                        <p:cond delay="indefinite"/>
                      </p:stCondLst>
                      <p:childTnLst>
                        <p:par>
                          <p:cTn id="68" fill="hold">
                            <p:stCondLst>
                              <p:cond delay="0"/>
                            </p:stCondLst>
                            <p:childTnLst>
                              <p:par>
                                <p:cTn id="6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1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2" fill="hold">
                      <p:stCondLst>
                        <p:cond delay="indefinite"/>
                      </p:stCondLst>
                      <p:childTnLst>
                        <p:par>
                          <p:cTn id="73" fill="hold">
                            <p:stCondLst>
                              <p:cond delay="0"/>
                            </p:stCondLst>
                            <p:childTnLst>
                              <p:par>
                                <p:cTn id="74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6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7" fill="hold">
                      <p:stCondLst>
                        <p:cond delay="indefinite"/>
                      </p:stCondLst>
                      <p:childTnLst>
                        <p:par>
                          <p:cTn id="78" fill="hold">
                            <p:stCondLst>
                              <p:cond delay="0"/>
                            </p:stCondLst>
                            <p:childTnLst>
                              <p:par>
                                <p:cTn id="7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1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4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7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0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3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6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9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2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5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8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1" dur="50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4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7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0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3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6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9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2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5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8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1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4" dur="5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7" dur="500"/>
                                        <p:tgtEl>
                                          <p:spTgt spid="4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0" dur="500"/>
                                        <p:tgtEl>
                                          <p:spTgt spid="4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3" dur="5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6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9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0" fill="hold">
                      <p:stCondLst>
                        <p:cond delay="indefinite"/>
                      </p:stCondLst>
                      <p:childTnLst>
                        <p:par>
                          <p:cTn id="161" fill="hold">
                            <p:stCondLst>
                              <p:cond delay="0"/>
                            </p:stCondLst>
                            <p:childTnLst>
                              <p:par>
                                <p:cTn id="162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4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7" dur="500"/>
                                        <p:tgtEl>
                                          <p:spTgt spid="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0" dur="5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3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6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9" dur="500"/>
                                        <p:tgtEl>
                                          <p:spTgt spid="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8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2" dur="5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3" fill="hold">
                      <p:stCondLst>
                        <p:cond delay="indefinite"/>
                      </p:stCondLst>
                      <p:childTnLst>
                        <p:par>
                          <p:cTn id="184" fill="hold">
                            <p:stCondLst>
                              <p:cond delay="0"/>
                            </p:stCondLst>
                            <p:childTnLst>
                              <p:par>
                                <p:cTn id="18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7" dur="5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8" fill="hold">
                      <p:stCondLst>
                        <p:cond delay="indefinite"/>
                      </p:stCondLst>
                      <p:childTnLst>
                        <p:par>
                          <p:cTn id="189" fill="hold">
                            <p:stCondLst>
                              <p:cond delay="0"/>
                            </p:stCondLst>
                            <p:childTnLst>
                              <p:par>
                                <p:cTn id="19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2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5" grpId="0" animBg="1"/>
      <p:bldP spid="6" grpId="0" animBg="1"/>
      <p:bldP spid="7" grpId="0" animBg="1"/>
      <p:bldP spid="8" grpId="0" animBg="1"/>
      <p:bldP spid="9" grpId="0" animBg="1"/>
      <p:bldP spid="10" grpId="0" animBg="1"/>
      <p:bldP spid="11" grpId="0" animBg="1"/>
      <p:bldP spid="12" grpId="0" animBg="1"/>
      <p:bldP spid="13" grpId="0" animBg="1"/>
      <p:bldP spid="19" grpId="0" animBg="1"/>
      <p:bldP spid="20" grpId="0" animBg="1"/>
      <p:bldP spid="21" grpId="0" animBg="1"/>
      <p:bldP spid="22" grpId="0" animBg="1"/>
      <p:bldP spid="23" grpId="0" animBg="1"/>
      <p:bldP spid="24" grpId="0" animBg="1"/>
      <p:bldP spid="25" grpId="0" animBg="1"/>
      <p:bldP spid="26" grpId="0" animBg="1"/>
      <p:bldP spid="27" grpId="0" animBg="1"/>
      <p:bldP spid="28" grpId="0" animBg="1"/>
      <p:bldP spid="29" grpId="0" animBg="1"/>
      <p:bldP spid="39" grpId="0"/>
      <p:bldP spid="40" grpId="0"/>
      <p:bldP spid="41" grpId="0" animBg="1"/>
      <p:bldP spid="42" grpId="0"/>
      <p:bldP spid="43" grpId="0"/>
      <p:bldP spid="45" grpId="0"/>
      <p:bldP spid="46" grpId="0"/>
      <p:bldP spid="47" grpId="0"/>
      <p:bldP spid="48" grpId="0"/>
      <p:bldP spid="49" grpId="0"/>
      <p:bldP spid="50" grpId="0"/>
      <p:bldP spid="51" grpId="0" animBg="1"/>
      <p:bldP spid="53" grpId="0" animBg="1"/>
      <p:bldP spid="54" grpId="0" animBg="1"/>
      <p:bldP spid="55" grpId="0" animBg="1"/>
      <p:bldP spid="56" grpId="0" animBg="1"/>
      <p:bldP spid="57" grpId="0" animBg="1"/>
      <p:bldP spid="6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29EFD03-22B5-BD44-AC68-D3B3D422356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207058" y="2475275"/>
            <a:ext cx="3388631" cy="3795991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3ED752A-BA8B-2017-80BE-43BFEA6984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242" y="2475275"/>
            <a:ext cx="3458524" cy="390319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BE4C48F-3A04-C2C9-0540-D526DE65FE4E}"/>
              </a:ext>
            </a:extLst>
          </p:cNvPr>
          <p:cNvSpPr txBox="1"/>
          <p:nvPr/>
        </p:nvSpPr>
        <p:spPr>
          <a:xfrm>
            <a:off x="467822" y="1569342"/>
            <a:ext cx="248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</a:t>
            </a:r>
            <a:r>
              <a:rPr lang="en-US" altLang="zh-CN" dirty="0"/>
              <a:t>roup 1</a:t>
            </a:r>
            <a:endParaRPr lang="en-US" dirty="0"/>
          </a:p>
          <a:p>
            <a:pPr algn="ctr"/>
            <a:r>
              <a:rPr lang="en-US" dirty="0"/>
              <a:t>NHW ROCAUC &gt; 61%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A45356-ED9C-1EE9-842E-CD458E7E2715}"/>
              </a:ext>
            </a:extLst>
          </p:cNvPr>
          <p:cNvSpPr txBox="1"/>
          <p:nvPr/>
        </p:nvSpPr>
        <p:spPr>
          <a:xfrm>
            <a:off x="4549812" y="1576846"/>
            <a:ext cx="248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</a:t>
            </a:r>
            <a:r>
              <a:rPr lang="en-US" altLang="zh-CN" dirty="0"/>
              <a:t>roup 2</a:t>
            </a:r>
            <a:endParaRPr lang="en-US" dirty="0"/>
          </a:p>
          <a:p>
            <a:pPr algn="ctr"/>
            <a:r>
              <a:rPr lang="en-US" dirty="0"/>
              <a:t>NHW ROCAUC &lt; 61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B11A90-218E-4925-B882-039F48DBCEB5}"/>
              </a:ext>
            </a:extLst>
          </p:cNvPr>
          <p:cNvSpPr txBox="1"/>
          <p:nvPr/>
        </p:nvSpPr>
        <p:spPr>
          <a:xfrm>
            <a:off x="8688675" y="1715345"/>
            <a:ext cx="3035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Overall Patient distribution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2B791C-C3DB-DA33-9D6D-16EA8CA52D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00160" y="2306330"/>
            <a:ext cx="2770678" cy="39649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DA5BA21-3C56-CEE8-DE4A-557979F9BAA4}"/>
              </a:ext>
            </a:extLst>
          </p:cNvPr>
          <p:cNvSpPr txBox="1"/>
          <p:nvPr/>
        </p:nvSpPr>
        <p:spPr>
          <a:xfrm>
            <a:off x="64609" y="1845814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37AAFDF-56D7-F6BE-A6E2-0915058DED61}"/>
              </a:ext>
            </a:extLst>
          </p:cNvPr>
          <p:cNvSpPr txBox="1"/>
          <p:nvPr/>
        </p:nvSpPr>
        <p:spPr>
          <a:xfrm>
            <a:off x="3992248" y="1864397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B437A7-A8C8-9B13-DABB-70F58D92A1E9}"/>
              </a:ext>
            </a:extLst>
          </p:cNvPr>
          <p:cNvSpPr txBox="1"/>
          <p:nvPr/>
        </p:nvSpPr>
        <p:spPr>
          <a:xfrm>
            <a:off x="8018010" y="1845814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558F578-1BBB-A19D-7A5C-1BA88CD6993C}"/>
              </a:ext>
            </a:extLst>
          </p:cNvPr>
          <p:cNvSpPr txBox="1"/>
          <p:nvPr/>
        </p:nvSpPr>
        <p:spPr>
          <a:xfrm>
            <a:off x="64609" y="-38050"/>
            <a:ext cx="120372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 Figure 2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365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32F4930-EDEC-D198-5D92-06C42E608F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8219" y="3747546"/>
            <a:ext cx="5971649" cy="29572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9C68266-2B2D-1757-B292-F518D7421F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4679" y="322746"/>
            <a:ext cx="4385538" cy="33137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20EB22-369F-DD3F-6F94-8579DC28DED6}"/>
              </a:ext>
            </a:extLst>
          </p:cNvPr>
          <p:cNvSpPr txBox="1"/>
          <p:nvPr/>
        </p:nvSpPr>
        <p:spPr>
          <a:xfrm>
            <a:off x="87079" y="203282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6AB2B92-D387-EAEA-9F62-C1799276C61B}"/>
              </a:ext>
            </a:extLst>
          </p:cNvPr>
          <p:cNvSpPr txBox="1"/>
          <p:nvPr/>
        </p:nvSpPr>
        <p:spPr>
          <a:xfrm>
            <a:off x="5856007" y="203282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3BF2A2-EE71-EC10-A97A-0E9F2BD83850}"/>
              </a:ext>
            </a:extLst>
          </p:cNvPr>
          <p:cNvSpPr txBox="1"/>
          <p:nvPr/>
        </p:nvSpPr>
        <p:spPr>
          <a:xfrm>
            <a:off x="75751" y="3676194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01D6A0-220B-5666-91AB-345FDFF153B2}"/>
              </a:ext>
            </a:extLst>
          </p:cNvPr>
          <p:cNvSpPr txBox="1"/>
          <p:nvPr/>
        </p:nvSpPr>
        <p:spPr>
          <a:xfrm>
            <a:off x="5844679" y="3676194"/>
            <a:ext cx="251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9C5EC8F-3E46-355A-9229-E574F9AC4D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3835" y="397106"/>
            <a:ext cx="4593949" cy="33504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57DF091-AF42-CBE7-5C4C-BC8C9A51F9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29617" y="571482"/>
            <a:ext cx="1460252" cy="79249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228EDE7-8674-8444-43B2-433A1EFD5BD5}"/>
              </a:ext>
            </a:extLst>
          </p:cNvPr>
          <p:cNvSpPr txBox="1"/>
          <p:nvPr/>
        </p:nvSpPr>
        <p:spPr>
          <a:xfrm>
            <a:off x="0" y="1883081"/>
            <a:ext cx="867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accent6">
                    <a:lumMod val="40000"/>
                    <a:lumOff val="60000"/>
                  </a:schemeClr>
                </a:solidFill>
              </a:rPr>
              <a:t>Befo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A516B5A-ACFC-A34D-C6B0-41C64AED4A9C}"/>
              </a:ext>
            </a:extLst>
          </p:cNvPr>
          <p:cNvSpPr txBox="1"/>
          <p:nvPr/>
        </p:nvSpPr>
        <p:spPr>
          <a:xfrm>
            <a:off x="14258" y="5060195"/>
            <a:ext cx="695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Afte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97FDCA-3D59-07B8-FB9D-A860142584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7508" y="3717922"/>
            <a:ext cx="4593949" cy="307648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1C08137-2532-ED3A-BFB6-AF385A47562F}"/>
              </a:ext>
            </a:extLst>
          </p:cNvPr>
          <p:cNvSpPr txBox="1"/>
          <p:nvPr/>
        </p:nvSpPr>
        <p:spPr>
          <a:xfrm>
            <a:off x="0" y="-74340"/>
            <a:ext cx="61207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 Figure 3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2332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3</Words>
  <Application>Microsoft Office PowerPoint</Application>
  <PresentationFormat>Widescreen</PresentationFormat>
  <Paragraphs>40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ang, Yongchao</dc:creator>
  <cp:lastModifiedBy>Huang, Yongchao</cp:lastModifiedBy>
  <cp:revision>1</cp:revision>
  <dcterms:created xsi:type="dcterms:W3CDTF">2025-05-12T06:15:42Z</dcterms:created>
  <dcterms:modified xsi:type="dcterms:W3CDTF">2025-05-12T06:16:48Z</dcterms:modified>
</cp:coreProperties>
</file>